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64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 showGuides="1">
      <p:cViewPr varScale="1">
        <p:scale>
          <a:sx n="64" d="100"/>
          <a:sy n="64" d="100"/>
        </p:scale>
        <p:origin x="3378" y="90"/>
      </p:cViewPr>
      <p:guideLst>
        <p:guide orient="horz" pos="164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2F7E6F-DBCE-4E82-B78C-0C9A471F31AB}" type="datetimeFigureOut">
              <a:rPr lang="en-GB" smtClean="0"/>
              <a:t>06/09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8724B7-2C62-43A6-888E-7A5090A193D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7040125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2F7E6F-DBCE-4E82-B78C-0C9A471F31AB}" type="datetimeFigureOut">
              <a:rPr lang="en-GB" smtClean="0"/>
              <a:t>06/09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8724B7-2C62-43A6-888E-7A5090A193D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2382410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2F7E6F-DBCE-4E82-B78C-0C9A471F31AB}" type="datetimeFigureOut">
              <a:rPr lang="en-GB" smtClean="0"/>
              <a:t>06/09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8724B7-2C62-43A6-888E-7A5090A193D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6790108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2F7E6F-DBCE-4E82-B78C-0C9A471F31AB}" type="datetimeFigureOut">
              <a:rPr lang="en-GB" smtClean="0"/>
              <a:t>06/09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8724B7-2C62-43A6-888E-7A5090A193D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644731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2F7E6F-DBCE-4E82-B78C-0C9A471F31AB}" type="datetimeFigureOut">
              <a:rPr lang="en-GB" smtClean="0"/>
              <a:t>06/09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8724B7-2C62-43A6-888E-7A5090A193D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4351008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2F7E6F-DBCE-4E82-B78C-0C9A471F31AB}" type="datetimeFigureOut">
              <a:rPr lang="en-GB" smtClean="0"/>
              <a:t>06/09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8724B7-2C62-43A6-888E-7A5090A193D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8813936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2F7E6F-DBCE-4E82-B78C-0C9A471F31AB}" type="datetimeFigureOut">
              <a:rPr lang="en-GB" smtClean="0"/>
              <a:t>06/09/2023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8724B7-2C62-43A6-888E-7A5090A193D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5697701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2F7E6F-DBCE-4E82-B78C-0C9A471F31AB}" type="datetimeFigureOut">
              <a:rPr lang="en-GB" smtClean="0"/>
              <a:t>06/09/2023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8724B7-2C62-43A6-888E-7A5090A193D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5755941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2F7E6F-DBCE-4E82-B78C-0C9A471F31AB}" type="datetimeFigureOut">
              <a:rPr lang="en-GB" smtClean="0"/>
              <a:t>06/09/2023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8724B7-2C62-43A6-888E-7A5090A193D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456285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2F7E6F-DBCE-4E82-B78C-0C9A471F31AB}" type="datetimeFigureOut">
              <a:rPr lang="en-GB" smtClean="0"/>
              <a:t>06/09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8724B7-2C62-43A6-888E-7A5090A193D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0807275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2F7E6F-DBCE-4E82-B78C-0C9A471F31AB}" type="datetimeFigureOut">
              <a:rPr lang="en-GB" smtClean="0"/>
              <a:t>06/09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8724B7-2C62-43A6-888E-7A5090A193D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751076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42F7E6F-DBCE-4E82-B78C-0C9A471F31AB}" type="datetimeFigureOut">
              <a:rPr lang="en-GB" smtClean="0"/>
              <a:t>06/09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48724B7-2C62-43A6-888E-7A5090A193D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6361637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" name="Group 7">
            <a:extLst>
              <a:ext uri="{FF2B5EF4-FFF2-40B4-BE49-F238E27FC236}">
                <a16:creationId xmlns:a16="http://schemas.microsoft.com/office/drawing/2014/main" id="{2F0D201A-D7EC-45AF-8AFA-C2822C24E696}"/>
              </a:ext>
            </a:extLst>
          </p:cNvPr>
          <p:cNvGrpSpPr/>
          <p:nvPr/>
        </p:nvGrpSpPr>
        <p:grpSpPr>
          <a:xfrm>
            <a:off x="552450" y="633415"/>
            <a:ext cx="5771247" cy="4213839"/>
            <a:chOff x="247650" y="309565"/>
            <a:chExt cx="5771247" cy="4213839"/>
          </a:xfrm>
        </p:grpSpPr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id="{766F2D11-3971-46E6-A943-1FBCCBCBEFB8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247650" y="319089"/>
              <a:ext cx="2885172" cy="2100262"/>
            </a:xfrm>
            <a:prstGeom prst="rect">
              <a:avLst/>
            </a:prstGeom>
          </p:spPr>
        </p:pic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5F23D15B-BD58-4A38-9A6D-A441CB6F8AEA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3133725" y="309565"/>
              <a:ext cx="2885172" cy="2100262"/>
            </a:xfrm>
            <a:prstGeom prst="rect">
              <a:avLst/>
            </a:prstGeom>
          </p:spPr>
        </p:pic>
        <p:pic>
          <p:nvPicPr>
            <p:cNvPr id="6" name="Picture 5">
              <a:extLst>
                <a:ext uri="{FF2B5EF4-FFF2-40B4-BE49-F238E27FC236}">
                  <a16:creationId xmlns:a16="http://schemas.microsoft.com/office/drawing/2014/main" id="{CECAA24A-2A51-4C49-BC03-068E6CFDA2B3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247650" y="2423143"/>
              <a:ext cx="2885172" cy="2100261"/>
            </a:xfrm>
            <a:prstGeom prst="rect">
              <a:avLst/>
            </a:prstGeom>
          </p:spPr>
        </p:pic>
        <p:pic>
          <p:nvPicPr>
            <p:cNvPr id="7" name="Content Placeholder 4">
              <a:extLst>
                <a:ext uri="{FF2B5EF4-FFF2-40B4-BE49-F238E27FC236}">
                  <a16:creationId xmlns:a16="http://schemas.microsoft.com/office/drawing/2014/main" id="{65E1048E-D569-4A88-98ED-27C64CB364D6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3133725" y="2415825"/>
              <a:ext cx="2885172" cy="2100260"/>
            </a:xfrm>
            <a:prstGeom prst="rect">
              <a:avLst/>
            </a:prstGeom>
          </p:spPr>
        </p:pic>
      </p:grpSp>
      <p:sp>
        <p:nvSpPr>
          <p:cNvPr id="9" name="TextBox 8">
            <a:extLst>
              <a:ext uri="{FF2B5EF4-FFF2-40B4-BE49-F238E27FC236}">
                <a16:creationId xmlns:a16="http://schemas.microsoft.com/office/drawing/2014/main" id="{EF3ACB0A-2472-41D2-8329-E5E17CBD80C4}"/>
              </a:ext>
            </a:extLst>
          </p:cNvPr>
          <p:cNvSpPr txBox="1"/>
          <p:nvPr/>
        </p:nvSpPr>
        <p:spPr>
          <a:xfrm>
            <a:off x="534303" y="273607"/>
            <a:ext cx="39626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b="1" dirty="0"/>
              <a:t>A)</a:t>
            </a:r>
            <a:endParaRPr lang="en-GB" b="1" dirty="0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F6415F9D-B5E7-4DFF-88AE-D1454041C328}"/>
              </a:ext>
            </a:extLst>
          </p:cNvPr>
          <p:cNvSpPr txBox="1"/>
          <p:nvPr/>
        </p:nvSpPr>
        <p:spPr>
          <a:xfrm>
            <a:off x="551547" y="4904404"/>
            <a:ext cx="39626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b="1" dirty="0"/>
              <a:t>B)</a:t>
            </a:r>
            <a:endParaRPr lang="en-GB" b="1" dirty="0"/>
          </a:p>
        </p:txBody>
      </p:sp>
      <p:grpSp>
        <p:nvGrpSpPr>
          <p:cNvPr id="15" name="Group 14">
            <a:extLst>
              <a:ext uri="{FF2B5EF4-FFF2-40B4-BE49-F238E27FC236}">
                <a16:creationId xmlns:a16="http://schemas.microsoft.com/office/drawing/2014/main" id="{1ACB5094-4438-4B1F-A47C-D835F2A34A1A}"/>
              </a:ext>
            </a:extLst>
          </p:cNvPr>
          <p:cNvGrpSpPr/>
          <p:nvPr/>
        </p:nvGrpSpPr>
        <p:grpSpPr>
          <a:xfrm>
            <a:off x="543828" y="5273735"/>
            <a:ext cx="5779869" cy="4200524"/>
            <a:chOff x="543828" y="4997510"/>
            <a:chExt cx="5779869" cy="4200524"/>
          </a:xfrm>
        </p:grpSpPr>
        <p:pic>
          <p:nvPicPr>
            <p:cNvPr id="11" name="Picture 10">
              <a:extLst>
                <a:ext uri="{FF2B5EF4-FFF2-40B4-BE49-F238E27FC236}">
                  <a16:creationId xmlns:a16="http://schemas.microsoft.com/office/drawing/2014/main" id="{A6BA7462-9AFE-4248-AC2C-B861F900DA4F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552449" y="4997510"/>
              <a:ext cx="2885173" cy="2100262"/>
            </a:xfrm>
            <a:prstGeom prst="rect">
              <a:avLst/>
            </a:prstGeom>
          </p:spPr>
        </p:pic>
        <p:pic>
          <p:nvPicPr>
            <p:cNvPr id="12" name="Picture 11">
              <a:extLst>
                <a:ext uri="{FF2B5EF4-FFF2-40B4-BE49-F238E27FC236}">
                  <a16:creationId xmlns:a16="http://schemas.microsoft.com/office/drawing/2014/main" id="{D15F9ABC-9FE5-4014-A6FA-D2DEC4CFADD1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3438524" y="4997510"/>
              <a:ext cx="2885173" cy="2100262"/>
            </a:xfrm>
            <a:prstGeom prst="rect">
              <a:avLst/>
            </a:prstGeom>
          </p:spPr>
        </p:pic>
        <p:pic>
          <p:nvPicPr>
            <p:cNvPr id="13" name="Picture 12">
              <a:extLst>
                <a:ext uri="{FF2B5EF4-FFF2-40B4-BE49-F238E27FC236}">
                  <a16:creationId xmlns:a16="http://schemas.microsoft.com/office/drawing/2014/main" id="{D1AEBC97-DB19-46EC-AD67-D9DA92657B97}"/>
                </a:ext>
              </a:extLst>
            </p:cNvPr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543828" y="7097772"/>
              <a:ext cx="2885172" cy="2100262"/>
            </a:xfrm>
            <a:prstGeom prst="rect">
              <a:avLst/>
            </a:prstGeom>
          </p:spPr>
        </p:pic>
        <p:pic>
          <p:nvPicPr>
            <p:cNvPr id="14" name="Content Placeholder 4">
              <a:extLst>
                <a:ext uri="{FF2B5EF4-FFF2-40B4-BE49-F238E27FC236}">
                  <a16:creationId xmlns:a16="http://schemas.microsoft.com/office/drawing/2014/main" id="{F10E7404-19E0-4CAE-88E5-D97A7575D37B}"/>
                </a:ext>
              </a:extLst>
            </p:cNvPr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3429000" y="7097771"/>
              <a:ext cx="2885172" cy="2100262"/>
            </a:xfrm>
            <a:prstGeom prst="rect">
              <a:avLst/>
            </a:prstGeom>
          </p:spPr>
        </p:pic>
      </p:grpSp>
      <p:sp>
        <p:nvSpPr>
          <p:cNvPr id="16" name="TextBox 15">
            <a:extLst>
              <a:ext uri="{FF2B5EF4-FFF2-40B4-BE49-F238E27FC236}">
                <a16:creationId xmlns:a16="http://schemas.microsoft.com/office/drawing/2014/main" id="{B2AFA71C-FAF8-48DD-9EE4-9C5A103E7D7A}"/>
              </a:ext>
            </a:extLst>
          </p:cNvPr>
          <p:cNvSpPr txBox="1"/>
          <p:nvPr/>
        </p:nvSpPr>
        <p:spPr>
          <a:xfrm>
            <a:off x="551548" y="9848850"/>
            <a:ext cx="5772150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/>
              <a:t>Supplementary Figure 1. Distribution of individual total (combined adenomatous and serrated polyp) colorectal polyp counts according to seAFOod trial treatment allocation by factorial </a:t>
            </a:r>
            <a:r>
              <a:rPr lang="en-US" sz="1200" b="1" dirty="0" smtClean="0"/>
              <a:t>margins and PTGS </a:t>
            </a:r>
            <a:r>
              <a:rPr lang="en-US" sz="1200" b="1" smtClean="0"/>
              <a:t>SNP genotypes.</a:t>
            </a:r>
            <a:r>
              <a:rPr lang="en-US" sz="1200" smtClean="0"/>
              <a:t> </a:t>
            </a:r>
            <a:r>
              <a:rPr lang="en-US" sz="1200" dirty="0"/>
              <a:t>A) </a:t>
            </a:r>
            <a:r>
              <a:rPr lang="en-US" sz="1200" i="1" dirty="0"/>
              <a:t>PTGS1</a:t>
            </a:r>
            <a:r>
              <a:rPr lang="en-US" sz="1200" dirty="0"/>
              <a:t> SNP rs4837960, and B) </a:t>
            </a:r>
            <a:r>
              <a:rPr lang="en-US" sz="1200" i="1" dirty="0"/>
              <a:t>PTGS2</a:t>
            </a:r>
            <a:r>
              <a:rPr lang="en-US" sz="1200" dirty="0"/>
              <a:t> SNP rs2745557. Data were stratified by genotype as the common heterozygote </a:t>
            </a:r>
            <a:r>
              <a:rPr lang="en-US" sz="1200" i="1" dirty="0"/>
              <a:t>versus</a:t>
            </a:r>
            <a:r>
              <a:rPr lang="en-US" sz="1200" dirty="0"/>
              <a:t> the combined heterozygote and rare homozygote (see also table 2). The difference between total colorectal polyp number between treatment groups for each genotype was compared using the Kruskal-Wallis rank test.</a:t>
            </a:r>
            <a:endParaRPr lang="en-GB" sz="1200" b="1" dirty="0"/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FBA1B92C-E4F6-45C7-B015-1F26BFF45D5A}"/>
              </a:ext>
            </a:extLst>
          </p:cNvPr>
          <p:cNvSpPr txBox="1"/>
          <p:nvPr/>
        </p:nvSpPr>
        <p:spPr>
          <a:xfrm>
            <a:off x="1694997" y="990600"/>
            <a:ext cx="60007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P=0.03</a:t>
            </a:r>
            <a:endParaRPr lang="en-GB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F36F3F13-FE1D-4E9E-BB34-122439CE3DB4}"/>
              </a:ext>
            </a:extLst>
          </p:cNvPr>
          <p:cNvSpPr txBox="1"/>
          <p:nvPr/>
        </p:nvSpPr>
        <p:spPr>
          <a:xfrm>
            <a:off x="4581072" y="990600"/>
            <a:ext cx="60007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P=0.13</a:t>
            </a:r>
            <a:endParaRPr lang="en-GB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174F4FF7-4B49-476C-95F1-CDAA8308B47E}"/>
              </a:ext>
            </a:extLst>
          </p:cNvPr>
          <p:cNvSpPr txBox="1"/>
          <p:nvPr/>
        </p:nvSpPr>
        <p:spPr>
          <a:xfrm>
            <a:off x="1694997" y="5621396"/>
            <a:ext cx="60007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P=0.90</a:t>
            </a:r>
            <a:endParaRPr lang="en-GB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09A49A39-EDDE-4C32-9E97-8EB3AAEF7FBE}"/>
              </a:ext>
            </a:extLst>
          </p:cNvPr>
          <p:cNvSpPr txBox="1"/>
          <p:nvPr/>
        </p:nvSpPr>
        <p:spPr>
          <a:xfrm>
            <a:off x="4585381" y="5643844"/>
            <a:ext cx="60007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P=0.01</a:t>
            </a:r>
            <a:endParaRPr lang="en-GB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498CB5B6-BA2C-4782-946F-CF35FB94A11B}"/>
              </a:ext>
            </a:extLst>
          </p:cNvPr>
          <p:cNvSpPr txBox="1"/>
          <p:nvPr/>
        </p:nvSpPr>
        <p:spPr>
          <a:xfrm>
            <a:off x="1694997" y="7757855"/>
            <a:ext cx="60007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P=0.83</a:t>
            </a:r>
            <a:endParaRPr lang="en-GB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C79DB40E-45A1-409C-A8D9-2D411EBDAAFB}"/>
              </a:ext>
            </a:extLst>
          </p:cNvPr>
          <p:cNvSpPr txBox="1"/>
          <p:nvPr/>
        </p:nvSpPr>
        <p:spPr>
          <a:xfrm>
            <a:off x="4571548" y="7751620"/>
            <a:ext cx="60007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P=0.56</a:t>
            </a:r>
            <a:endParaRPr lang="en-GB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38EF431B-3B2F-48E3-97C7-D72123331FD4}"/>
              </a:ext>
            </a:extLst>
          </p:cNvPr>
          <p:cNvSpPr txBox="1"/>
          <p:nvPr/>
        </p:nvSpPr>
        <p:spPr>
          <a:xfrm>
            <a:off x="1694997" y="3155963"/>
            <a:ext cx="60007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P=0.72</a:t>
            </a:r>
            <a:endParaRPr lang="en-GB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0BCF8F82-61D6-488B-ABF4-3C84466D5FEA}"/>
              </a:ext>
            </a:extLst>
          </p:cNvPr>
          <p:cNvSpPr txBox="1"/>
          <p:nvPr/>
        </p:nvSpPr>
        <p:spPr>
          <a:xfrm>
            <a:off x="4581072" y="3155963"/>
            <a:ext cx="60007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P=0.09</a:t>
            </a:r>
            <a:endParaRPr lang="en-GB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8011545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6</TotalTime>
  <Words>100</Words>
  <Application>Microsoft Office PowerPoint</Application>
  <PresentationFormat>Widescreen</PresentationFormat>
  <Paragraphs>1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rk Hull</dc:creator>
  <cp:lastModifiedBy>Mark Hull</cp:lastModifiedBy>
  <cp:revision>8</cp:revision>
  <dcterms:created xsi:type="dcterms:W3CDTF">2022-11-19T14:33:40Z</dcterms:created>
  <dcterms:modified xsi:type="dcterms:W3CDTF">2023-09-06T12:02:04Z</dcterms:modified>
</cp:coreProperties>
</file>